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C4FB2F-D39A-4FFC-9627-584BEDD379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31174-2B3C-480E-BA9C-A97063BDE8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FA55D2-29AC-43CF-88FD-3552CCEA558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AD9E6-8835-4121-BF13-A573F39057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FB977B-7CA6-4678-AFE2-231B9FC025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E2A5C1-573D-4671-9EB9-D446042AA2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55EE9-BCAA-410F-8208-A90766CA87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D84E49-C4F5-42E4-A3A9-04849D7BDB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4AD2F6-FFA3-4165-A940-82336F2BBE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1DAF6A-92D1-435F-ADE4-DD1297386D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92F07-B46F-4A15-9E2C-917C9A348F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81A8A-5D8F-4FDB-8856-EAE0CF4047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C4EAB0-AA6D-45C9-BD09-3094CF05CE36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hyperlink" Target="http://blast.ncbi.nlm.nih.gov/" TargetMode="External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13284" t="27775" r="15841" b="61156"/>
          <a:stretch/>
        </p:blipFill>
        <p:spPr>
          <a:xfrm>
            <a:off x="250920" y="2357280"/>
            <a:ext cx="7993080" cy="10004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rcRect l="6295" t="18994" r="36419" b="43358"/>
          <a:stretch/>
        </p:blipFill>
        <p:spPr>
          <a:xfrm>
            <a:off x="395280" y="3595680"/>
            <a:ext cx="6121440" cy="3218040"/>
          </a:xfrm>
          <a:prstGeom prst="rect">
            <a:avLst/>
          </a:prstGeom>
          <a:ln w="0">
            <a:noFill/>
          </a:ln>
        </p:spPr>
      </p:pic>
      <p:sp>
        <p:nvSpPr>
          <p:cNvPr id="43" name="TextBox 6"/>
          <p:cNvSpPr/>
          <p:nvPr/>
        </p:nvSpPr>
        <p:spPr>
          <a:xfrm>
            <a:off x="250920" y="189000"/>
            <a:ext cx="8642160" cy="3291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a. 756 bp DNA sequence of IS element gene sequence found repeated 6 times in </a:t>
            </a:r>
            <a:r>
              <a:rPr b="1" i="1" lang="en-GB" sz="1000" spc="-1" strike="noStrike">
                <a:solidFill>
                  <a:srgbClr val="000000"/>
                </a:solidFill>
                <a:latin typeface="Calibri"/>
              </a:rPr>
              <a:t>B. bacteriovorus </a:t>
            </a: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Tiberius genome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ATGCCTCGCCATTACCAAAAATCAGACGATCAAATAATTTTAGAAGAAATCAAAGCCGTTATTGCAATTAGAGCCACCTATGGCTACCGCCGGGTGACAACGATGGTGAATCGCCAAAGATCCCTTGATGGTCGCAATAAGATCAATCGCAAGCGTGTTCAAAGAATCATGCGCATGAATGGTCTTTCATTGCCACAAACAATGCCACAGCCAAAAAGGCCACATACGGGAGTTGTTATGACTATGTTCCCGAATCTGCGTTGGTGTTCAGATGGCATGGAAATCCGCTGTTTTAACGGCGACAAAGTTTTCGTGGCGTTTGCTTTGGATTGTTGTGATCGCGAAGCATTTGCTTACGTCGCTAGGACTGAGCCGCTATCAGCTACCGACATAGAGGAATTGATGGTTAAAGCTGTTGAAGCGAGATTTGGTGAGTCATTGAGATGTCCTCGCGAAATTCAGTGGTTGTCAGATCGAGGGTCAATTTACCGTGCGAAGTCCGTGAAGGATCTTGGCAAAGAGTTAAATCTGAATTGCTGTTACACCAGAGCCTACAGCCCAGAATCCAACGGCATGGCTGAAGCATTCGTTAAAACAATCAAAAGGGATTACGTTTATCAGGCTGACTGTGACAGCGCAGAGACGGTTCTCAAGCTTTTGCCGCAGTGGTTTGCAGATTATAACAATATTGCTCCGCACTCAGCACTTGGCATGAAGAGCCCGGTCGAGTACAAAGGGTCCGTGAACTTTT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b. Blast X (</a:t>
            </a:r>
            <a:r>
              <a:rPr b="0" lang="en-GB" sz="1000" spc="-1" strike="noStrike" u="sng">
                <a:solidFill>
                  <a:srgbClr val="0000ff"/>
                </a:solidFill>
                <a:uFillTx/>
                <a:latin typeface="Calibri"/>
                <a:hlinkClick r:id="rId3"/>
              </a:rPr>
              <a:t>http://blast.ncbi.nlm.nih.gov</a:t>
            </a: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)  outcomes for a search with IS element gene showing: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    </a:t>
            </a: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Predicted domains encoded by the IS element seque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Calibri"/>
              </a:rPr>
              <a:t>c. Alignment of Tiberius encoded IS element product translated from bases 7-732 with insertion element IS2 transposase catalytic protein InsD of </a:t>
            </a:r>
            <a:r>
              <a:rPr b="1" i="1" lang="en-GB" sz="1000" spc="-1" strike="noStrike">
                <a:solidFill>
                  <a:srgbClr val="000000"/>
                </a:solidFill>
                <a:latin typeface="Calibri"/>
              </a:rPr>
              <a:t>E.col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4T12:56:37Z</dcterms:created>
  <dc:creator>Information Services</dc:creator>
  <dc:description/>
  <dc:language>en-US</dc:language>
  <cp:lastModifiedBy>Information Services</cp:lastModifiedBy>
  <dcterms:modified xsi:type="dcterms:W3CDTF">2012-11-21T12:26:47Z</dcterms:modified>
  <cp:revision>11</cp:revision>
  <dc:subject/>
  <dc:title>Slide 1</dc:title>
</cp:coreProperties>
</file>